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73" r:id="rId2"/>
    <p:sldId id="3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9900"/>
    <a:srgbClr val="FFCCCC"/>
    <a:srgbClr val="FFFF00"/>
    <a:srgbClr val="FF0000"/>
    <a:srgbClr val="CC00CC"/>
    <a:srgbClr val="99FF99"/>
    <a:srgbClr val="FFFFCC"/>
    <a:srgbClr val="008000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45" autoAdjust="0"/>
    <p:restoredTop sz="94660"/>
  </p:normalViewPr>
  <p:slideViewPr>
    <p:cSldViewPr>
      <p:cViewPr varScale="1">
        <p:scale>
          <a:sx n="134" d="100"/>
          <a:sy n="134" d="100"/>
        </p:scale>
        <p:origin x="-123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58F8CD-2879-4F1B-94DD-5811664DCE44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75F491-E61C-48BD-BBE0-B1554C9129E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2430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26020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6342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4318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835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0215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0119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8167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8905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94426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7733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1254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7C210-C353-4F62-8314-8FA3B45D9E49}" type="datetimeFigureOut">
              <a:rPr lang="en-GB" smtClean="0"/>
              <a:pPr/>
              <a:t>14/1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1FA8D-BB9D-46FF-8D9B-86C5285B21B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1697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8072449"/>
              </p:ext>
            </p:extLst>
          </p:nvPr>
        </p:nvGraphicFramePr>
        <p:xfrm>
          <a:off x="395536" y="260648"/>
          <a:ext cx="6480059" cy="6120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60" name="SPW 12.0 Graph" r:id="rId3" imgW="5496120" imgH="5187240" progId="SigmaPlotGraphicObject.11">
                  <p:embed/>
                </p:oleObj>
              </mc:Choice>
              <mc:Fallback>
                <p:oleObj name="SPW 12.0 Graph" r:id="rId3" imgW="5496120" imgH="5187240" progId="SigmaPlotGraphicObject.11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5536" y="260648"/>
                        <a:ext cx="6480059" cy="61206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 rot="16200000">
            <a:off x="2158551" y="5066010"/>
            <a:ext cx="458459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Galactose</a:t>
            </a:r>
            <a:endParaRPr lang="en-GB" sz="900"/>
          </a:p>
        </p:txBody>
      </p:sp>
      <p:sp>
        <p:nvSpPr>
          <p:cNvPr id="6" name="TextBox 5"/>
          <p:cNvSpPr txBox="1"/>
          <p:nvPr/>
        </p:nvSpPr>
        <p:spPr>
          <a:xfrm rot="16200000">
            <a:off x="2435540" y="5109291"/>
            <a:ext cx="371897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Glucose</a:t>
            </a:r>
            <a:endParaRPr lang="en-GB" sz="900"/>
          </a:p>
        </p:txBody>
      </p:sp>
      <p:sp>
        <p:nvSpPr>
          <p:cNvPr id="7" name="TextBox 6"/>
          <p:cNvSpPr txBox="1"/>
          <p:nvPr/>
        </p:nvSpPr>
        <p:spPr>
          <a:xfrm rot="16200000">
            <a:off x="2770912" y="5143755"/>
            <a:ext cx="302968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Xylose</a:t>
            </a:r>
            <a:endParaRPr lang="en-GB" sz="900"/>
          </a:p>
        </p:txBody>
      </p:sp>
      <p:sp>
        <p:nvSpPr>
          <p:cNvPr id="8" name="TextBox 7"/>
          <p:cNvSpPr txBox="1"/>
          <p:nvPr/>
        </p:nvSpPr>
        <p:spPr>
          <a:xfrm rot="16200000">
            <a:off x="2824352" y="5075628"/>
            <a:ext cx="439223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Mannose</a:t>
            </a:r>
            <a:endParaRPr lang="en-GB" sz="900"/>
          </a:p>
        </p:txBody>
      </p:sp>
      <p:sp>
        <p:nvSpPr>
          <p:cNvPr id="9" name="TextBox 8"/>
          <p:cNvSpPr txBox="1"/>
          <p:nvPr/>
        </p:nvSpPr>
        <p:spPr>
          <a:xfrm rot="16200000">
            <a:off x="1758807" y="5057995"/>
            <a:ext cx="474489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Arabinose</a:t>
            </a:r>
            <a:endParaRPr lang="en-GB" sz="90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1649217" y="5047575"/>
            <a:ext cx="495328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Rhamnose</a:t>
            </a:r>
            <a:endParaRPr lang="en-GB" sz="90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1333817" y="5132534"/>
            <a:ext cx="32541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Fucose</a:t>
            </a:r>
            <a:endParaRPr lang="en-GB" sz="90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4793408" y="5135740"/>
            <a:ext cx="318998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>
                <a:solidFill>
                  <a:srgbClr val="FF0000"/>
                </a:solidFill>
              </a:rPr>
              <a:t>Apiose</a:t>
            </a:r>
            <a:endParaRPr lang="en-GB" sz="900">
              <a:solidFill>
                <a:srgbClr val="FF0000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6020177" y="5049343"/>
            <a:ext cx="221214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GalA</a:t>
            </a:r>
            <a:endParaRPr lang="en-GB" sz="90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6108971" y="5187838"/>
            <a:ext cx="214802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GlcA</a:t>
            </a:r>
            <a:endParaRPr lang="en-GB" sz="90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5147047" y="5052384"/>
            <a:ext cx="48571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Cellobiose</a:t>
            </a:r>
            <a:endParaRPr lang="en-GB" sz="90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1771814" y="3934975"/>
            <a:ext cx="862416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2-</a:t>
            </a:r>
            <a:r>
              <a:rPr lang="en-GB" sz="900" i="1" smtClean="0"/>
              <a:t>O</a:t>
            </a:r>
            <a:r>
              <a:rPr lang="en-GB" sz="900" smtClean="0"/>
              <a:t>-Methylxylose</a:t>
            </a:r>
            <a:endParaRPr lang="en-GB" sz="90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2164114" y="3732996"/>
            <a:ext cx="458459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Galactose</a:t>
            </a:r>
            <a:endParaRPr lang="en-GB" sz="90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1761127" y="3308963"/>
            <a:ext cx="474489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Arabinose</a:t>
            </a:r>
            <a:endParaRPr lang="en-GB" sz="90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1645051" y="3427075"/>
            <a:ext cx="495328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Rhamnose</a:t>
            </a:r>
            <a:endParaRPr lang="en-GB" sz="90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1267306" y="3773109"/>
            <a:ext cx="325410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Fucose</a:t>
            </a:r>
            <a:endParaRPr lang="en-GB" sz="900"/>
          </a:p>
        </p:txBody>
      </p:sp>
      <p:sp>
        <p:nvSpPr>
          <p:cNvPr id="25" name="TextBox 24"/>
          <p:cNvSpPr txBox="1"/>
          <p:nvPr/>
        </p:nvSpPr>
        <p:spPr>
          <a:xfrm>
            <a:off x="5271223" y="3383110"/>
            <a:ext cx="593111" cy="17953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>
              <a:lnSpc>
                <a:spcPts val="700"/>
              </a:lnSpc>
            </a:pPr>
            <a:r>
              <a:rPr lang="en-GB" sz="900" smtClean="0"/>
              <a:t>Galacturonic</a:t>
            </a:r>
          </a:p>
          <a:p>
            <a:pPr algn="r">
              <a:lnSpc>
                <a:spcPts val="700"/>
              </a:lnSpc>
            </a:pPr>
            <a:r>
              <a:rPr lang="en-GB" sz="900" smtClean="0"/>
              <a:t>acid</a:t>
            </a:r>
            <a:endParaRPr lang="en-GB" sz="90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5856494" y="3505205"/>
            <a:ext cx="722955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Glucuronic acid</a:t>
            </a:r>
            <a:endParaRPr lang="en-GB" sz="90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4782755" y="3951298"/>
            <a:ext cx="318998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Apiose</a:t>
            </a:r>
            <a:endParaRPr lang="en-GB" sz="90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444725"/>
              </p:ext>
            </p:extLst>
          </p:nvPr>
        </p:nvGraphicFramePr>
        <p:xfrm>
          <a:off x="2267744" y="1090424"/>
          <a:ext cx="2833863" cy="2194560"/>
        </p:xfrm>
        <a:graphic>
          <a:graphicData uri="http://schemas.openxmlformats.org/drawingml/2006/table">
            <a:tbl>
              <a:tblPr firstRow="1" firstCol="1" bandRow="1"/>
              <a:tblGrid>
                <a:gridCol w="878523"/>
                <a:gridCol w="371013"/>
                <a:gridCol w="322898"/>
                <a:gridCol w="322898"/>
                <a:gridCol w="322898"/>
                <a:gridCol w="322898"/>
                <a:gridCol w="292735"/>
              </a:tblGrid>
              <a:tr h="108000">
                <a:tc row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Sugar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RT (min)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Molar ratio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0800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A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B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C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D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Lit</a:t>
                      </a:r>
                      <a:r>
                        <a:rPr lang="en-GB" sz="800" b="1" baseline="300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?</a:t>
                      </a:r>
                      <a:r>
                        <a:rPr lang="en-GB" sz="800" baseline="300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 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46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7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?</a:t>
                      </a:r>
                      <a:r>
                        <a:rPr lang="en-GB" sz="800" baseline="300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 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63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6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9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7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?</a:t>
                      </a:r>
                      <a:r>
                        <a:rPr lang="en-GB" sz="800" baseline="300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 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.8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9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7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4.3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.3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?</a:t>
                      </a:r>
                      <a:r>
                        <a:rPr lang="en-GB" sz="800" baseline="300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 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4.06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?</a:t>
                      </a:r>
                      <a:r>
                        <a:rPr lang="en-GB" sz="800" baseline="300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 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4.98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7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Fucose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5.37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6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Rhamnose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2.38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5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5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6.3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4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5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Arabinose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3.9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4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4.9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5.3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4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3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-</a:t>
                      </a:r>
                      <a:r>
                        <a:rPr lang="en-GB" sz="800" i="1">
                          <a:solidFill>
                            <a:srgbClr val="000000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O</a:t>
                      </a: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-Methylxylose</a:t>
                      </a:r>
                      <a:r>
                        <a:rPr lang="en-GB" sz="800" baseline="300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 3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7.0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3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smtClean="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Galactose (</a:t>
                      </a:r>
                      <a:r>
                        <a:rPr lang="en-GB" sz="600" smtClean="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D</a:t>
                      </a:r>
                      <a:r>
                        <a:rPr lang="en-GB" sz="800" smtClean="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 and </a:t>
                      </a:r>
                      <a:r>
                        <a:rPr lang="en-GB" sz="600" smtClean="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L</a:t>
                      </a:r>
                      <a:r>
                        <a:rPr lang="en-GB" sz="800" smtClean="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)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9.88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.6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.9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3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4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Glucose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3.5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1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Xylose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8.2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1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8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Apiose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58.38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6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3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6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2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?</a:t>
                      </a:r>
                      <a:r>
                        <a:rPr lang="en-GB" sz="800" baseline="300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 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75.31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5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Galacturonic acid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76.28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0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0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0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0.0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 b="1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0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80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Glucuronic acid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77.51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2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.4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0.7</a:t>
                      </a:r>
                      <a:endParaRPr lang="en-GB" sz="800"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Arial Narrow" pitchFamily="34" charset="0"/>
                          <a:ea typeface="Times New Roman"/>
                          <a:cs typeface="Arial"/>
                        </a:rPr>
                        <a:t>1</a:t>
                      </a:r>
                      <a:endParaRPr lang="en-GB" sz="800">
                        <a:solidFill>
                          <a:schemeClr val="tx1"/>
                        </a:solidFill>
                        <a:effectLst/>
                        <a:latin typeface="Arial Narrow" pitchFamily="34" charset="0"/>
                        <a:ea typeface="Times New Roman"/>
                      </a:endParaRPr>
                    </a:p>
                  </a:txBody>
                  <a:tcPr marL="68580" marR="68580" marT="0" marB="0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3" name="Rectangle 32"/>
          <p:cNvSpPr/>
          <p:nvPr/>
        </p:nvSpPr>
        <p:spPr>
          <a:xfrm>
            <a:off x="6730841" y="2009740"/>
            <a:ext cx="2161639" cy="39395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S1: Characterisation of purified </a:t>
            </a:r>
            <a:r>
              <a:rPr lang="en-GB" sz="1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Rosa </a:t>
            </a:r>
            <a:r>
              <a:rPr lang="en-GB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RG-II by HPLC.</a:t>
            </a:r>
            <a:endParaRPr lang="en-GB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(a) Profile of acid hydrolysis products of RG-II prep A.  </a:t>
            </a:r>
          </a:p>
          <a:p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(b) Marker sugars. </a:t>
            </a:r>
          </a:p>
          <a:p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PAD = pulsed amperometric detector.</a:t>
            </a:r>
          </a:p>
          <a:p>
            <a:pPr eaLnBrk="0" fontAlgn="base" hangingPunct="0"/>
            <a:r>
              <a:rPr lang="en-GB" sz="1000" u="sng">
                <a:latin typeface="Times New Roman" panose="02020603050405020304" pitchFamily="18" charset="0"/>
                <a:cs typeface="Times New Roman" panose="02020603050405020304" pitchFamily="18" charset="0"/>
              </a:rPr>
              <a:t>Inset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: Table of estimated molar ratios of monosaccharides present in each of four independently produced preparations of RG-II, A–D. Molar ratios are normalised relative to GalA, which is expected to be present at ~10 residues per RG-II molecule. RT = retention time.</a:t>
            </a:r>
          </a:p>
          <a:p>
            <a:pPr eaLnBrk="0" fontAlgn="base" hangingPunct="0"/>
            <a:r>
              <a:rPr lang="en-GB" sz="10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Expected molar ratio for pure RG-II (O'Neill et al., 2004).</a:t>
            </a:r>
          </a:p>
          <a:p>
            <a:pPr eaLnBrk="0" fontAlgn="base" hangingPunct="0"/>
            <a:r>
              <a:rPr lang="en-GB" sz="10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Approximate molar ratios of unknowns calculated assuming a response factor equal to that of fucose.</a:t>
            </a:r>
          </a:p>
          <a:p>
            <a:pPr eaLnBrk="0" fontAlgn="base" hangingPunct="0"/>
            <a:r>
              <a:rPr lang="en-GB" sz="10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Approximate molar ratio calculated assuming a response factor equal to that of xylose.</a:t>
            </a:r>
          </a:p>
          <a:p>
            <a:pPr eaLnBrk="0" fontAlgn="base" hangingPunct="0"/>
            <a:r>
              <a:rPr lang="en-GB" sz="10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Approximate molar ratio calculated assuming a response factor equal to that of galacturonic acid</a:t>
            </a:r>
            <a:r>
              <a:rPr lang="en-GB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236296" y="812141"/>
            <a:ext cx="101021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00FF"/>
                </a:solidFill>
              </a:rPr>
              <a:t>Chormova </a:t>
            </a:r>
            <a:r>
              <a:rPr lang="en-GB" sz="1000" i="1" smtClean="0">
                <a:solidFill>
                  <a:srgbClr val="0000FF"/>
                </a:solidFill>
              </a:rPr>
              <a:t>et al.</a:t>
            </a:r>
          </a:p>
          <a:p>
            <a:r>
              <a:rPr lang="en-GB" smtClean="0">
                <a:solidFill>
                  <a:srgbClr val="0000FF"/>
                </a:solidFill>
              </a:rPr>
              <a:t>Fig</a:t>
            </a:r>
            <a:r>
              <a:rPr lang="en-GB" smtClean="0">
                <a:solidFill>
                  <a:srgbClr val="0000FF"/>
                </a:solidFill>
              </a:rPr>
              <a:t>. S1</a:t>
            </a:r>
            <a:endParaRPr lang="en-GB">
              <a:solidFill>
                <a:srgbClr val="0000FF"/>
              </a:solidFill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611560" y="5069883"/>
            <a:ext cx="432048" cy="5289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Rectangle 38"/>
          <p:cNvSpPr/>
          <p:nvPr/>
        </p:nvSpPr>
        <p:spPr>
          <a:xfrm>
            <a:off x="611560" y="4660278"/>
            <a:ext cx="432048" cy="1831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TextBox 35"/>
          <p:cNvSpPr txBox="1"/>
          <p:nvPr/>
        </p:nvSpPr>
        <p:spPr>
          <a:xfrm>
            <a:off x="1201552" y="963409"/>
            <a:ext cx="279943" cy="220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200" smtClean="0"/>
              <a:t>(a)</a:t>
            </a:r>
            <a:endParaRPr lang="en-GB" sz="1200"/>
          </a:p>
        </p:txBody>
      </p:sp>
      <p:sp>
        <p:nvSpPr>
          <p:cNvPr id="37" name="TextBox 36"/>
          <p:cNvSpPr txBox="1"/>
          <p:nvPr/>
        </p:nvSpPr>
        <p:spPr>
          <a:xfrm>
            <a:off x="1115616" y="4736177"/>
            <a:ext cx="357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200" smtClean="0"/>
              <a:t>(b)</a:t>
            </a:r>
            <a:endParaRPr lang="en-GB" sz="1200"/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5873334" y="3467599"/>
            <a:ext cx="257450" cy="0"/>
          </a:xfrm>
          <a:prstGeom prst="straightConnector1">
            <a:avLst/>
          </a:prstGeom>
          <a:ln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 rot="16200000">
            <a:off x="3095872" y="5112497"/>
            <a:ext cx="365485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Sucrose</a:t>
            </a:r>
            <a:endParaRPr lang="en-GB" sz="90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3256367" y="5093261"/>
            <a:ext cx="403957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Fructose</a:t>
            </a:r>
            <a:endParaRPr lang="en-GB" sz="90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3620060" y="5138145"/>
            <a:ext cx="314189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Ribose</a:t>
            </a:r>
            <a:endParaRPr lang="en-GB" sz="90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5580566" y="5103680"/>
            <a:ext cx="383118" cy="138499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900" smtClean="0"/>
              <a:t>Maltose</a:t>
            </a:r>
            <a:endParaRPr lang="en-GB" sz="900"/>
          </a:p>
        </p:txBody>
      </p:sp>
    </p:spTree>
    <p:extLst>
      <p:ext uri="{BB962C8B-B14F-4D97-AF65-F5344CB8AC3E}">
        <p14:creationId xmlns:p14="http://schemas.microsoft.com/office/powerpoint/2010/main" val="11786010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9" name="Picture 2" descr="Cells Medium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825829" y="1656141"/>
            <a:ext cx="2861347" cy="13933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4803505" y="2188296"/>
            <a:ext cx="8917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RG-II dimer</a:t>
            </a:r>
            <a:endParaRPr lang="en-GB" sz="1200"/>
          </a:p>
        </p:txBody>
      </p:sp>
      <p:sp>
        <p:nvSpPr>
          <p:cNvPr id="12" name="TextBox 11"/>
          <p:cNvSpPr txBox="1"/>
          <p:nvPr/>
        </p:nvSpPr>
        <p:spPr>
          <a:xfrm>
            <a:off x="4714822" y="2513500"/>
            <a:ext cx="1143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RG-II monomer</a:t>
            </a:r>
            <a:endParaRPr lang="en-GB" sz="1200"/>
          </a:p>
        </p:txBody>
      </p:sp>
      <p:cxnSp>
        <p:nvCxnSpPr>
          <p:cNvPr id="13" name="Straight Connector 12"/>
          <p:cNvCxnSpPr/>
          <p:nvPr/>
        </p:nvCxnSpPr>
        <p:spPr>
          <a:xfrm flipH="1" flipV="1">
            <a:off x="4494461" y="2652000"/>
            <a:ext cx="29237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 flipV="1">
            <a:off x="4490125" y="2314894"/>
            <a:ext cx="29237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" descr="C:\Users\dchormov\AppData\Local\Microsoft\Windows\Temporary Internet Files\Content.Word\LAST EXPERIMENT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1053475" y="1660454"/>
            <a:ext cx="710213" cy="13257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>
            <a:off x="1785673" y="1404362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smtClean="0"/>
              <a:t>–½</a:t>
            </a:r>
            <a:endParaRPr lang="en-GB" sz="1200" b="1"/>
          </a:p>
        </p:txBody>
      </p:sp>
      <p:sp>
        <p:nvSpPr>
          <p:cNvPr id="17" name="TextBox 16"/>
          <p:cNvSpPr txBox="1"/>
          <p:nvPr/>
        </p:nvSpPr>
        <p:spPr>
          <a:xfrm>
            <a:off x="4687176" y="1268760"/>
            <a:ext cx="12189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smtClean="0"/>
              <a:t>h after</a:t>
            </a:r>
          </a:p>
          <a:p>
            <a:pPr algn="ctr"/>
            <a:r>
              <a:rPr lang="en-GB" sz="1200" b="1" smtClean="0"/>
              <a:t>adding [</a:t>
            </a:r>
            <a:r>
              <a:rPr lang="en-GB" sz="1200" b="1" baseline="30000" smtClean="0"/>
              <a:t>3</a:t>
            </a:r>
            <a:r>
              <a:rPr lang="en-GB" sz="1200" b="1" smtClean="0"/>
              <a:t>H]RG-II</a:t>
            </a:r>
            <a:endParaRPr lang="en-GB" sz="1200" b="1"/>
          </a:p>
        </p:txBody>
      </p:sp>
      <p:sp>
        <p:nvSpPr>
          <p:cNvPr id="18" name="TextBox 17"/>
          <p:cNvSpPr txBox="1"/>
          <p:nvPr/>
        </p:nvSpPr>
        <p:spPr>
          <a:xfrm>
            <a:off x="2126343" y="1404362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smtClean="0"/>
              <a:t>(0)</a:t>
            </a:r>
            <a:endParaRPr lang="en-GB" sz="1200" b="1"/>
          </a:p>
        </p:txBody>
      </p:sp>
      <p:sp>
        <p:nvSpPr>
          <p:cNvPr id="19" name="TextBox 18"/>
          <p:cNvSpPr txBox="1"/>
          <p:nvPr/>
        </p:nvSpPr>
        <p:spPr>
          <a:xfrm>
            <a:off x="2471557" y="1404362"/>
            <a:ext cx="2904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smtClean="0"/>
              <a:t>½</a:t>
            </a:r>
            <a:endParaRPr lang="en-GB" sz="1200" b="1"/>
          </a:p>
        </p:txBody>
      </p:sp>
      <p:sp>
        <p:nvSpPr>
          <p:cNvPr id="20" name="TextBox 19"/>
          <p:cNvSpPr txBox="1"/>
          <p:nvPr/>
        </p:nvSpPr>
        <p:spPr>
          <a:xfrm>
            <a:off x="2858759" y="140436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smtClean="0"/>
              <a:t>1</a:t>
            </a:r>
            <a:endParaRPr lang="en-GB" sz="1200" b="1"/>
          </a:p>
        </p:txBody>
      </p:sp>
      <p:sp>
        <p:nvSpPr>
          <p:cNvPr id="21" name="TextBox 20"/>
          <p:cNvSpPr txBox="1"/>
          <p:nvPr/>
        </p:nvSpPr>
        <p:spPr>
          <a:xfrm>
            <a:off x="3169687" y="140436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/>
              <a:t>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527544" y="140436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/>
              <a:t>4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42053" y="140436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/>
              <a:t>6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191915" y="140436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 smtClean="0"/>
              <a:t>24</a:t>
            </a:r>
            <a:endParaRPr lang="en-GB" sz="1200" b="1"/>
          </a:p>
        </p:txBody>
      </p:sp>
      <p:sp>
        <p:nvSpPr>
          <p:cNvPr id="3" name="Rectangle 2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1756505"/>
              </p:ext>
            </p:extLst>
          </p:nvPr>
        </p:nvGraphicFramePr>
        <p:xfrm>
          <a:off x="1054853" y="3429000"/>
          <a:ext cx="3229115" cy="25659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74" name="SPW 12.0 Graph" r:id="rId5" imgW="5381859" imgH="4276657" progId="SigmaPlotGraphicObject.11">
                  <p:embed/>
                </p:oleObj>
              </mc:Choice>
              <mc:Fallback>
                <p:oleObj name="SPW 12.0 Graph" r:id="rId5" imgW="5381859" imgH="4276657" progId="SigmaPlotGraphicObject.11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54853" y="3429000"/>
                        <a:ext cx="3229115" cy="2565994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Rectangle 2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38" name="TextBox 37"/>
          <p:cNvSpPr txBox="1"/>
          <p:nvPr/>
        </p:nvSpPr>
        <p:spPr>
          <a:xfrm>
            <a:off x="1119633" y="1405688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smtClean="0"/>
              <a:t>markers</a:t>
            </a:r>
            <a:endParaRPr lang="en-GB" sz="1000"/>
          </a:p>
        </p:txBody>
      </p:sp>
      <p:sp>
        <p:nvSpPr>
          <p:cNvPr id="27" name="Rectangle 29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41" name="TextBox 40"/>
          <p:cNvSpPr txBox="1"/>
          <p:nvPr/>
        </p:nvSpPr>
        <p:spPr>
          <a:xfrm>
            <a:off x="1734848" y="2996952"/>
            <a:ext cx="1363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solidFill>
                  <a:schemeClr val="bg1">
                    <a:lumMod val="50000"/>
                  </a:schemeClr>
                </a:solidFill>
              </a:rPr>
              <a:t>½–24 h incubation</a:t>
            </a:r>
            <a:endParaRPr lang="en-GB" sz="120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029512" y="4437112"/>
            <a:ext cx="314288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S2: Exogenous [</a:t>
            </a:r>
            <a:r>
              <a:rPr lang="en-GB" sz="1000" b="1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H]RG-II fails to dimerise in spent medium of cultured </a:t>
            </a:r>
            <a:r>
              <a:rPr lang="en-GB" sz="10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Rosa</a:t>
            </a:r>
            <a:r>
              <a:rPr lang="en-GB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  <a:endParaRPr lang="en-GB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Monomeric [</a:t>
            </a:r>
            <a:r>
              <a:rPr lang="en-GB" sz="100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H]RG-II (3.9 µM) was fed to cell-free spent medium of boron-starved 4-day-old </a:t>
            </a:r>
            <a:r>
              <a:rPr lang="en-GB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Rosa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 cultures at the same time as 1.2 mM H</a:t>
            </a:r>
            <a:r>
              <a:rPr lang="en-GB" sz="1000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BO</a:t>
            </a:r>
            <a:r>
              <a:rPr lang="en-GB" sz="1000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. Samples of the medium were electrophoresed at intervals. (a) The gel was fluorographed; (b) the relevant bands scintillation-counted.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899592" y="1124744"/>
            <a:ext cx="279943" cy="220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200" smtClean="0"/>
              <a:t>(a)</a:t>
            </a:r>
            <a:endParaRPr lang="en-GB" sz="1200"/>
          </a:p>
        </p:txBody>
      </p:sp>
      <p:sp>
        <p:nvSpPr>
          <p:cNvPr id="29" name="TextBox 28"/>
          <p:cNvSpPr txBox="1"/>
          <p:nvPr/>
        </p:nvSpPr>
        <p:spPr>
          <a:xfrm>
            <a:off x="899592" y="3712371"/>
            <a:ext cx="285051" cy="2206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200" smtClean="0"/>
              <a:t>(b)</a:t>
            </a:r>
            <a:endParaRPr lang="en-GB" sz="1200"/>
          </a:p>
        </p:txBody>
      </p:sp>
      <p:sp>
        <p:nvSpPr>
          <p:cNvPr id="30" name="TextBox 29"/>
          <p:cNvSpPr txBox="1"/>
          <p:nvPr/>
        </p:nvSpPr>
        <p:spPr>
          <a:xfrm>
            <a:off x="7236296" y="812141"/>
            <a:ext cx="101021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00FF"/>
                </a:solidFill>
              </a:rPr>
              <a:t>Chormova </a:t>
            </a:r>
            <a:r>
              <a:rPr lang="en-GB" sz="1000" i="1" smtClean="0">
                <a:solidFill>
                  <a:srgbClr val="0000FF"/>
                </a:solidFill>
              </a:rPr>
              <a:t>et al.</a:t>
            </a:r>
          </a:p>
          <a:p>
            <a:r>
              <a:rPr lang="en-GB" smtClean="0">
                <a:solidFill>
                  <a:srgbClr val="0000FF"/>
                </a:solidFill>
              </a:rPr>
              <a:t>Fig</a:t>
            </a:r>
            <a:r>
              <a:rPr lang="en-GB" smtClean="0">
                <a:solidFill>
                  <a:srgbClr val="0000FF"/>
                </a:solidFill>
              </a:rPr>
              <a:t>. </a:t>
            </a:r>
            <a:r>
              <a:rPr lang="en-GB" smtClean="0">
                <a:solidFill>
                  <a:srgbClr val="0000FF"/>
                </a:solidFill>
              </a:rPr>
              <a:t>S2</a:t>
            </a:r>
            <a:endParaRPr lang="en-GB">
              <a:solidFill>
                <a:srgbClr val="0000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33942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61</TotalTime>
  <Words>421</Words>
  <Application>Microsoft Office PowerPoint</Application>
  <PresentationFormat>On-screen Show (4:3)</PresentationFormat>
  <Paragraphs>171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SPW 12.0 Graph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Y Stephen</dc:creator>
  <cp:lastModifiedBy>FRY Stephen</cp:lastModifiedBy>
  <cp:revision>296</cp:revision>
  <dcterms:created xsi:type="dcterms:W3CDTF">2013-06-17T10:33:44Z</dcterms:created>
  <dcterms:modified xsi:type="dcterms:W3CDTF">2013-10-14T15:23:54Z</dcterms:modified>
</cp:coreProperties>
</file>